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5DAC"/>
    <a:srgbClr val="BEBEBE"/>
    <a:srgbClr val="9EB7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97"/>
    <p:restoredTop sz="95033" autoAdjust="0"/>
  </p:normalViewPr>
  <p:slideViewPr>
    <p:cSldViewPr snapToGrid="0">
      <p:cViewPr varScale="1">
        <p:scale>
          <a:sx n="54" d="100"/>
          <a:sy n="54" d="100"/>
        </p:scale>
        <p:origin x="286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51BF788-A5AC-4563-836F-A6517E13EDF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AFD37610-53A2-45F4-BA32-511312CCA45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11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D9AB03-F745-B556-25E0-EDC40512B4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C1447DDC-E7D1-94B4-18E6-F6A0768A8B7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61A69CDC-F101-6211-F381-AC22926293C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64A0074-D491-AEDE-6EF5-E256F02562D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610-53A2-45F4-BA32-511312CCA45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6871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7159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5457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814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5655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060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833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7395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996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025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019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559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7466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7EDAC7-48BC-0436-8939-09F3F7A8C0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909F476A-0641-B18F-4D75-01CE4427E6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09" y="366533"/>
            <a:ext cx="2828571" cy="1980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EBBAC269-6D75-A2A4-788E-33B3084B752F}"/>
              </a:ext>
            </a:extLst>
          </p:cNvPr>
          <p:cNvSpPr txBox="1"/>
          <p:nvPr/>
        </p:nvSpPr>
        <p:spPr>
          <a:xfrm>
            <a:off x="312472" y="8450853"/>
            <a:ext cx="6233056" cy="1499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4. Differential gene expression analysis in quadriceps of control, vehicle and </a:t>
            </a:r>
            <a:r>
              <a:rPr lang="en-GB" sz="1000" b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</a:t>
            </a:r>
            <a:r>
              <a:rPr lang="en-GB" sz="1000" b="1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b="1" i="1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at end-stage. a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ene ontology (GO) enrichment analysis of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ownregulated (DR) genes of vehicl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)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FOXO inhibitor) treated </a:t>
            </a:r>
            <a:r>
              <a:rPr lang="en-GB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i="1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SOD1) mice vs control (WT) mice starting the treatment at symptomatic postnatal day 90 (P90)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O enrichment analysis of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upregulated (UR) genes of vehicl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)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</a:t>
            </a:r>
            <a:r>
              <a:rPr lang="en-GB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i="1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vs WT mice starting the treatment at P90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)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O enrichment analysis of DR genes of vehicl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)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SOD1 mice vs WT mice starting the treatment at pre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ymptomatic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50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)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O enrichment analysis of UR genes of vehicle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)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SOD1 mice vs WT mice starting the treatment at presymptomatic P50. </a:t>
            </a:r>
            <a:endParaRPr lang="es-ES" sz="1000" b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3" name="CuadroTexto 40">
            <a:extLst>
              <a:ext uri="{FF2B5EF4-FFF2-40B4-BE49-F238E27FC236}">
                <a16:creationId xmlns:a16="http://schemas.microsoft.com/office/drawing/2014/main" id="{8A9950D5-5F61-00BE-B900-C958CF028DB2}"/>
              </a:ext>
            </a:extLst>
          </p:cNvPr>
          <p:cNvSpPr txBox="1"/>
          <p:nvPr/>
        </p:nvSpPr>
        <p:spPr>
          <a:xfrm>
            <a:off x="279000" y="6168760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g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CuadroTexto 40">
            <a:extLst>
              <a:ext uri="{FF2B5EF4-FFF2-40B4-BE49-F238E27FC236}">
                <a16:creationId xmlns:a16="http://schemas.microsoft.com/office/drawing/2014/main" id="{0F784402-3DA3-88DB-D8DD-238778F7600A}"/>
              </a:ext>
            </a:extLst>
          </p:cNvPr>
          <p:cNvSpPr txBox="1"/>
          <p:nvPr/>
        </p:nvSpPr>
        <p:spPr>
          <a:xfrm>
            <a:off x="3446702" y="6168760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h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CuadroTexto 40">
            <a:extLst>
              <a:ext uri="{FF2B5EF4-FFF2-40B4-BE49-F238E27FC236}">
                <a16:creationId xmlns:a16="http://schemas.microsoft.com/office/drawing/2014/main" id="{380383A9-13B9-D494-0CDB-240E82B1E224}"/>
              </a:ext>
            </a:extLst>
          </p:cNvPr>
          <p:cNvSpPr txBox="1"/>
          <p:nvPr/>
        </p:nvSpPr>
        <p:spPr>
          <a:xfrm>
            <a:off x="279000" y="4192995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CuadroTexto 40">
            <a:extLst>
              <a:ext uri="{FF2B5EF4-FFF2-40B4-BE49-F238E27FC236}">
                <a16:creationId xmlns:a16="http://schemas.microsoft.com/office/drawing/2014/main" id="{85B2A416-F1DE-97A5-B0BD-218674A4A9D2}"/>
              </a:ext>
            </a:extLst>
          </p:cNvPr>
          <p:cNvSpPr txBox="1"/>
          <p:nvPr/>
        </p:nvSpPr>
        <p:spPr>
          <a:xfrm>
            <a:off x="3446702" y="4192995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f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CuadroTexto 40">
            <a:extLst>
              <a:ext uri="{FF2B5EF4-FFF2-40B4-BE49-F238E27FC236}">
                <a16:creationId xmlns:a16="http://schemas.microsoft.com/office/drawing/2014/main" id="{E66022DA-FF1E-4116-0E7B-1B8D0A8D3303}"/>
              </a:ext>
            </a:extLst>
          </p:cNvPr>
          <p:cNvSpPr txBox="1"/>
          <p:nvPr/>
        </p:nvSpPr>
        <p:spPr>
          <a:xfrm>
            <a:off x="279000" y="2204490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c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CuadroTexto 40">
            <a:extLst>
              <a:ext uri="{FF2B5EF4-FFF2-40B4-BE49-F238E27FC236}">
                <a16:creationId xmlns:a16="http://schemas.microsoft.com/office/drawing/2014/main" id="{0E5CB453-2F1D-F7A7-9154-790E35E53E4A}"/>
              </a:ext>
            </a:extLst>
          </p:cNvPr>
          <p:cNvSpPr txBox="1"/>
          <p:nvPr/>
        </p:nvSpPr>
        <p:spPr>
          <a:xfrm>
            <a:off x="3446702" y="2204490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d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uadroTexto 40">
            <a:extLst>
              <a:ext uri="{FF2B5EF4-FFF2-40B4-BE49-F238E27FC236}">
                <a16:creationId xmlns:a16="http://schemas.microsoft.com/office/drawing/2014/main" id="{E001E2E8-64D1-3D71-9BB5-7EA6D74F0B73}"/>
              </a:ext>
            </a:extLst>
          </p:cNvPr>
          <p:cNvSpPr txBox="1"/>
          <p:nvPr/>
        </p:nvSpPr>
        <p:spPr>
          <a:xfrm>
            <a:off x="3446702" y="267294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b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CuadroTexto 40">
            <a:extLst>
              <a:ext uri="{FF2B5EF4-FFF2-40B4-BE49-F238E27FC236}">
                <a16:creationId xmlns:a16="http://schemas.microsoft.com/office/drawing/2014/main" id="{D4B8EF22-8828-E40E-17E3-0BA785D136DD}"/>
              </a:ext>
            </a:extLst>
          </p:cNvPr>
          <p:cNvSpPr txBox="1"/>
          <p:nvPr/>
        </p:nvSpPr>
        <p:spPr>
          <a:xfrm>
            <a:off x="279000" y="267294"/>
            <a:ext cx="568949" cy="5101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pic>
        <p:nvPicPr>
          <p:cNvPr id="19" name="Imagen 18">
            <a:extLst>
              <a:ext uri="{FF2B5EF4-FFF2-40B4-BE49-F238E27FC236}">
                <a16:creationId xmlns:a16="http://schemas.microsoft.com/office/drawing/2014/main" id="{FAD277E9-F46F-1DBA-84FF-C6A9FD9462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510" y="366533"/>
            <a:ext cx="2828571" cy="1980000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2698F22E-CD27-9B1A-3A86-0805A07EFD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07" y="4407138"/>
            <a:ext cx="2828572" cy="1980000"/>
          </a:xfrm>
          <a:prstGeom prst="rect">
            <a:avLst/>
          </a:prstGeom>
        </p:spPr>
      </p:pic>
      <p:pic>
        <p:nvPicPr>
          <p:cNvPr id="26" name="Imagen 25">
            <a:extLst>
              <a:ext uri="{FF2B5EF4-FFF2-40B4-BE49-F238E27FC236}">
                <a16:creationId xmlns:a16="http://schemas.microsoft.com/office/drawing/2014/main" id="{22AD62CA-AF6E-E5D2-69DF-2FE847E9489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509" y="4407138"/>
            <a:ext cx="2828572" cy="1980000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B1DF971D-8BC0-1BA3-8077-5B745830719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08" y="2378130"/>
            <a:ext cx="2828572" cy="1980000"/>
          </a:xfrm>
          <a:prstGeom prst="rect">
            <a:avLst/>
          </a:prstGeom>
        </p:spPr>
      </p:pic>
      <p:pic>
        <p:nvPicPr>
          <p:cNvPr id="33" name="Imagen 32">
            <a:extLst>
              <a:ext uri="{FF2B5EF4-FFF2-40B4-BE49-F238E27FC236}">
                <a16:creationId xmlns:a16="http://schemas.microsoft.com/office/drawing/2014/main" id="{88DAF222-D062-8A2C-9F73-5A5FCED2EB4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509" y="2378130"/>
            <a:ext cx="2828572" cy="1980000"/>
          </a:xfrm>
          <a:prstGeom prst="rect">
            <a:avLst/>
          </a:prstGeom>
        </p:spPr>
      </p:pic>
      <p:pic>
        <p:nvPicPr>
          <p:cNvPr id="35" name="Imagen 34">
            <a:extLst>
              <a:ext uri="{FF2B5EF4-FFF2-40B4-BE49-F238E27FC236}">
                <a16:creationId xmlns:a16="http://schemas.microsoft.com/office/drawing/2014/main" id="{A61B7FCA-2D64-84CB-85B6-C4F38BB1AD9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07" y="6466681"/>
            <a:ext cx="2828572" cy="1980000"/>
          </a:xfrm>
          <a:prstGeom prst="rect">
            <a:avLst/>
          </a:prstGeom>
        </p:spPr>
      </p:pic>
      <p:pic>
        <p:nvPicPr>
          <p:cNvPr id="36" name="Imagen 35">
            <a:extLst>
              <a:ext uri="{FF2B5EF4-FFF2-40B4-BE49-F238E27FC236}">
                <a16:creationId xmlns:a16="http://schemas.microsoft.com/office/drawing/2014/main" id="{99EC16BE-040E-3C6C-8D4C-EC6CA62953C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509" y="6466681"/>
            <a:ext cx="2828572" cy="19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97379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10</TotalTime>
  <Words>162</Words>
  <Application>Microsoft Office PowerPoint</Application>
  <PresentationFormat>A4 (210 x 297 mm)</PresentationFormat>
  <Paragraphs>10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NHOA VIDAL GIL</dc:creator>
  <cp:lastModifiedBy>AINHOA VIDAL GIL</cp:lastModifiedBy>
  <cp:revision>387</cp:revision>
  <cp:lastPrinted>2026-03-24T15:11:51Z</cp:lastPrinted>
  <dcterms:created xsi:type="dcterms:W3CDTF">2025-08-03T15:24:02Z</dcterms:created>
  <dcterms:modified xsi:type="dcterms:W3CDTF">2026-05-27T13:33:36Z</dcterms:modified>
</cp:coreProperties>
</file>